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1B485-83CD-454C-9449-162EBCEC72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6A54E-3880-4423-BCCF-07571DEC90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3A066-08C2-4505-B082-E56FC9F6BC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49112-6595-432D-ACA1-022B7ADE5B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9FC03-F18B-4C8A-BA96-11E92F7CD4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35B5C-89BB-4A55-828A-153C873CBF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45195-25E0-4966-9C78-7FFD4BC10D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8A96B-9205-40A3-B46E-E29647E19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B3AED-D127-45B6-8FC9-CF474AC645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2891C-C21B-4117-A9C5-D3A8B3993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57C68-AD28-4966-BE65-6BEA29196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0F774-657B-4530-A195-48AA06E8EF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EBDC66-1BD9-4669-B6F3-A27C32CAFD7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lpha-diversity, beta-diversity, and predicted average 16S rRNA gene copy numb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1560600"/>
            <a:ext cx="4800600" cy="37670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 R Thompson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9 (2017) doi:10.1038/nature246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0-30T05:53:48Z</dcterms:created>
  <dc:creator>ravikumar.n</dc:creator>
  <dc:description/>
  <dc:language>en-US</dc:language>
  <cp:lastModifiedBy>ravikumar.n</cp:lastModifiedBy>
  <dcterms:modified xsi:type="dcterms:W3CDTF">2017-10-30T05:53:53Z</dcterms:modified>
  <cp:revision>1</cp:revision>
  <dc:subject/>
  <dc:title>Alpha-diversity, beta-diversity, and predicted average 16S rRNA gene copy number</dc:title>
</cp:coreProperties>
</file>